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17968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857320" y="514440"/>
            <a:ext cx="3429000" cy="2571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51312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179680" y="651312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728B93-A83E-4B34-B085-9457EABEC2D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lide Number Placeholder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81AE0E-6F65-4933-9087-7EE91D58B28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2575B4-3496-4E1F-8981-59EEC6EDD1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806FD-DF64-4070-ADC3-5EEED0DE7B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8445D-BCA7-4C98-B085-1998FB9062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4B959-A886-419D-BA17-2B18933957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04B6B-0FC1-482F-B797-647BA80809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415156-1EBA-460D-A495-1B81D787A1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17BA4-8A8D-4E3F-AE95-1310956868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537ABF-EC2B-4092-AAE6-A0E10C3A13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21D8BA-8AA4-433D-961E-44B7DF27FB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6D6743-165A-4366-8BDA-51BB1FC192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2DC09-961E-4F88-837A-FD9C7101E2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B5C45B-BF7F-4B97-89A7-A3727D4F38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669124-F792-4804-A652-E461C71EECE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533520" y="2747880"/>
          <a:ext cx="3235320" cy="1044720"/>
        </p:xfrm>
        <a:graphic>
          <a:graphicData uri="http://schemas.openxmlformats.org/drawingml/2006/table">
            <a:tbl>
              <a:tblPr/>
              <a:tblGrid>
                <a:gridCol w="817560"/>
                <a:gridCol w="371520"/>
                <a:gridCol w="631800"/>
                <a:gridCol w="412560"/>
                <a:gridCol w="412920"/>
                <a:gridCol w="588960"/>
              </a:tblGrid>
              <a:tr h="173160">
                <a:tc gridSpan="6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Leaf 0.2 FTS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2160"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DEG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I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-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Comm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172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Activa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3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316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Suppress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1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3975120" y="2733840"/>
          <a:ext cx="3235320" cy="1044360"/>
        </p:xfrm>
        <a:graphic>
          <a:graphicData uri="http://schemas.openxmlformats.org/drawingml/2006/table">
            <a:tbl>
              <a:tblPr/>
              <a:tblGrid>
                <a:gridCol w="817560"/>
                <a:gridCol w="371520"/>
                <a:gridCol w="631800"/>
                <a:gridCol w="412560"/>
                <a:gridCol w="412920"/>
                <a:gridCol w="588960"/>
              </a:tblGrid>
              <a:tr h="172800">
                <a:tc gridSpan="6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Leaf 0.5 FTS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2160"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DEG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I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-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Comm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Activa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2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Suppress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1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0" name=""/>
          <p:cNvGraphicFramePr/>
          <p:nvPr/>
        </p:nvGraphicFramePr>
        <p:xfrm>
          <a:off x="3983040" y="4267080"/>
          <a:ext cx="3103560" cy="971640"/>
        </p:xfrm>
        <a:graphic>
          <a:graphicData uri="http://schemas.openxmlformats.org/drawingml/2006/table">
            <a:tbl>
              <a:tblPr/>
              <a:tblGrid>
                <a:gridCol w="839880"/>
                <a:gridCol w="320760"/>
                <a:gridCol w="556920"/>
                <a:gridCol w="424080"/>
                <a:gridCol w="357120"/>
                <a:gridCol w="604800"/>
              </a:tblGrid>
              <a:tr h="158040">
                <a:tc gridSpan="6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Panicle 0.5 FTS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2160"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DEG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I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-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Comm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Activa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768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Suppress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7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1" name=""/>
          <p:cNvGraphicFramePr/>
          <p:nvPr/>
        </p:nvGraphicFramePr>
        <p:xfrm>
          <a:off x="531720" y="1292400"/>
          <a:ext cx="3200400" cy="971280"/>
        </p:xfrm>
        <a:graphic>
          <a:graphicData uri="http://schemas.openxmlformats.org/drawingml/2006/table">
            <a:tbl>
              <a:tblPr/>
              <a:tblGrid>
                <a:gridCol w="779400"/>
                <a:gridCol w="316080"/>
                <a:gridCol w="606240"/>
                <a:gridCol w="433440"/>
                <a:gridCol w="389160"/>
                <a:gridCol w="676080"/>
              </a:tblGrid>
              <a:tr h="157680">
                <a:tc gridSpan="6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Root 0.2 FTSW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2160"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DEG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I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-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Comm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Activa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768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Suppress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7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2" name=""/>
          <p:cNvGraphicFramePr/>
          <p:nvPr/>
        </p:nvGraphicFramePr>
        <p:xfrm>
          <a:off x="3962520" y="1289160"/>
          <a:ext cx="3214440" cy="971280"/>
        </p:xfrm>
        <a:graphic>
          <a:graphicData uri="http://schemas.openxmlformats.org/drawingml/2006/table">
            <a:tbl>
              <a:tblPr/>
              <a:tblGrid>
                <a:gridCol w="760320"/>
                <a:gridCol w="371520"/>
                <a:gridCol w="650880"/>
                <a:gridCol w="417600"/>
                <a:gridCol w="417240"/>
                <a:gridCol w="596880"/>
              </a:tblGrid>
              <a:tr h="157680">
                <a:tc gridSpan="6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Root 0.5 FTS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2160"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DEG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I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-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Comm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Activa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5 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Suppress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3" name=""/>
          <p:cNvGraphicFramePr/>
          <p:nvPr/>
        </p:nvGraphicFramePr>
        <p:xfrm>
          <a:off x="511200" y="4267080"/>
          <a:ext cx="3193920" cy="971640"/>
        </p:xfrm>
        <a:graphic>
          <a:graphicData uri="http://schemas.openxmlformats.org/drawingml/2006/table">
            <a:tbl>
              <a:tblPr/>
              <a:tblGrid>
                <a:gridCol w="804960"/>
                <a:gridCol w="365040"/>
                <a:gridCol w="630360"/>
                <a:gridCol w="404640"/>
                <a:gridCol w="406440"/>
                <a:gridCol w="582480"/>
              </a:tblGrid>
              <a:tr h="162000">
                <a:tc gridSpan="6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nicle 0.2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FTS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2000"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EG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NIL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-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mm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200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tiva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164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uppress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&gt;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&gt;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4" name="TextBox 14"/>
          <p:cNvSpPr/>
          <p:nvPr/>
        </p:nvSpPr>
        <p:spPr>
          <a:xfrm>
            <a:off x="228600" y="85680"/>
            <a:ext cx="8305920" cy="55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6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fferentially expressed genes in IR77298-14-1-2-B-10 versus IR77298-14-1-2-B-13 and IR64 under 0.2 FTSW and 0.5 FTSW in the root, leaf, and panic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27T00:21:41Z</dcterms:created>
  <dc:creator>user1</dc:creator>
  <dc:description/>
  <dc:language>en-US</dc:language>
  <cp:lastModifiedBy>user1</cp:lastModifiedBy>
  <dcterms:modified xsi:type="dcterms:W3CDTF">2012-02-14T03:16:47Z</dcterms:modified>
  <cp:revision>27</cp:revision>
  <dc:subject/>
  <dc:title>Slide 1</dc:title>
</cp:coreProperties>
</file>